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2192000" cy="21599525"/>
  <p:notesSz cx="6889750" cy="100218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804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69" autoAdjust="0"/>
    <p:restoredTop sz="94660"/>
  </p:normalViewPr>
  <p:slideViewPr>
    <p:cSldViewPr snapToGrid="0" showGuides="1">
      <p:cViewPr>
        <p:scale>
          <a:sx n="66" d="100"/>
          <a:sy n="66" d="100"/>
        </p:scale>
        <p:origin x="1210" y="-4426"/>
      </p:cViewPr>
      <p:guideLst>
        <p:guide orient="horz" pos="6804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3534924"/>
            <a:ext cx="10363200" cy="7519835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11344752"/>
            <a:ext cx="9144000" cy="5214884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148C1-55A0-4997-84EF-5A281F848CE0}" type="datetimeFigureOut">
              <a:rPr lang="en-IN" smtClean="0"/>
              <a:t>07-12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07CB22-7B16-469C-8CA6-633CD22F8A7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294155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148C1-55A0-4997-84EF-5A281F848CE0}" type="datetimeFigureOut">
              <a:rPr lang="en-IN" smtClean="0"/>
              <a:t>07-12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07CB22-7B16-469C-8CA6-633CD22F8A7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532001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1149975"/>
            <a:ext cx="2628900" cy="1830459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1149975"/>
            <a:ext cx="7734300" cy="1830459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148C1-55A0-4997-84EF-5A281F848CE0}" type="datetimeFigureOut">
              <a:rPr lang="en-IN" smtClean="0"/>
              <a:t>07-12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07CB22-7B16-469C-8CA6-633CD22F8A7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297411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148C1-55A0-4997-84EF-5A281F848CE0}" type="datetimeFigureOut">
              <a:rPr lang="en-IN" smtClean="0"/>
              <a:t>07-12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07CB22-7B16-469C-8CA6-633CD22F8A7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883161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5384888"/>
            <a:ext cx="10515600" cy="8984801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4454688"/>
            <a:ext cx="10515600" cy="4724895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148C1-55A0-4997-84EF-5A281F848CE0}" type="datetimeFigureOut">
              <a:rPr lang="en-IN" smtClean="0"/>
              <a:t>07-12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07CB22-7B16-469C-8CA6-633CD22F8A7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991732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5749874"/>
            <a:ext cx="5181600" cy="137047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5749874"/>
            <a:ext cx="5181600" cy="137047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148C1-55A0-4997-84EF-5A281F848CE0}" type="datetimeFigureOut">
              <a:rPr lang="en-IN" smtClean="0"/>
              <a:t>07-12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07CB22-7B16-469C-8CA6-633CD22F8A7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946712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149979"/>
            <a:ext cx="10515600" cy="417491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5294885"/>
            <a:ext cx="5157787" cy="2594941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7889827"/>
            <a:ext cx="5157787" cy="1160474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5294885"/>
            <a:ext cx="5183188" cy="2594941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7889827"/>
            <a:ext cx="5183188" cy="1160474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148C1-55A0-4997-84EF-5A281F848CE0}" type="datetimeFigureOut">
              <a:rPr lang="en-IN" smtClean="0"/>
              <a:t>07-12-2021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07CB22-7B16-469C-8CA6-633CD22F8A7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747102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148C1-55A0-4997-84EF-5A281F848CE0}" type="datetimeFigureOut">
              <a:rPr lang="en-IN" smtClean="0"/>
              <a:t>07-12-2021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07CB22-7B16-469C-8CA6-633CD22F8A7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423679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148C1-55A0-4997-84EF-5A281F848CE0}" type="datetimeFigureOut">
              <a:rPr lang="en-IN" smtClean="0"/>
              <a:t>07-12-2021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07CB22-7B16-469C-8CA6-633CD22F8A7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512703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439968"/>
            <a:ext cx="3932237" cy="5039889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3109937"/>
            <a:ext cx="6172200" cy="15349662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6479857"/>
            <a:ext cx="3932237" cy="12004738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148C1-55A0-4997-84EF-5A281F848CE0}" type="datetimeFigureOut">
              <a:rPr lang="en-IN" smtClean="0"/>
              <a:t>07-12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07CB22-7B16-469C-8CA6-633CD22F8A7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111427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439968"/>
            <a:ext cx="3932237" cy="5039889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3109937"/>
            <a:ext cx="6172200" cy="15349662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6479857"/>
            <a:ext cx="3932237" cy="12004738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148C1-55A0-4997-84EF-5A281F848CE0}" type="datetimeFigureOut">
              <a:rPr lang="en-IN" smtClean="0"/>
              <a:t>07-12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07CB22-7B16-469C-8CA6-633CD22F8A7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889567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1149979"/>
            <a:ext cx="10515600" cy="417491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5749874"/>
            <a:ext cx="10515600" cy="137047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20019564"/>
            <a:ext cx="2743200" cy="11499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F148C1-55A0-4997-84EF-5A281F848CE0}" type="datetimeFigureOut">
              <a:rPr lang="en-IN" smtClean="0"/>
              <a:t>07-12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20019564"/>
            <a:ext cx="4114800" cy="11499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20019564"/>
            <a:ext cx="2743200" cy="11499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07CB22-7B16-469C-8CA6-633CD22F8A7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716851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BA3C9BB-A6E6-4A72-838D-680372AB011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86951" y="1174217"/>
            <a:ext cx="9285013" cy="718171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F4AFADE-7256-48B0-AB65-21BD59DFA7F3}"/>
              </a:ext>
            </a:extLst>
          </p:cNvPr>
          <p:cNvSpPr txBox="1"/>
          <p:nvPr/>
        </p:nvSpPr>
        <p:spPr>
          <a:xfrm>
            <a:off x="786201" y="757024"/>
            <a:ext cx="119466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Triplicates of western  blots  showing the downregulation of MOAP1 protein by  hcmv-miR-UL70-3p </a:t>
            </a:r>
          </a:p>
        </p:txBody>
      </p:sp>
      <p:pic>
        <p:nvPicPr>
          <p:cNvPr id="32" name="Picture 31">
            <a:extLst>
              <a:ext uri="{FF2B5EF4-FFF2-40B4-BE49-F238E27FC236}">
                <a16:creationId xmlns:a16="http://schemas.microsoft.com/office/drawing/2014/main" id="{21D7EEC9-6E75-49B1-A1FD-44671A1C91A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91525" y="13540692"/>
            <a:ext cx="2688569" cy="2481287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63A29189-C65B-496C-9CD2-324989393EF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12794" y="13492401"/>
            <a:ext cx="2469094" cy="2706859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58D905E4-088B-423F-A799-1ED1D2B73DB8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15652" b="-6787"/>
          <a:stretch/>
        </p:blipFill>
        <p:spPr>
          <a:xfrm>
            <a:off x="5795439" y="13687562"/>
            <a:ext cx="2658086" cy="2578014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F3872521-3C7A-4EDF-86CD-77B13E53A788}"/>
              </a:ext>
            </a:extLst>
          </p:cNvPr>
          <p:cNvSpPr txBox="1"/>
          <p:nvPr/>
        </p:nvSpPr>
        <p:spPr>
          <a:xfrm>
            <a:off x="975366" y="9372875"/>
            <a:ext cx="970219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Triplicates of western  blots  showing the downregulation of MOAP1 protein by siRNA of MOAP1 and hcmv-miR-UL70-3p 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FFE3E8A5-39B4-444F-9192-8AFD603B4206}"/>
              </a:ext>
            </a:extLst>
          </p:cNvPr>
          <p:cNvSpPr txBox="1"/>
          <p:nvPr/>
        </p:nvSpPr>
        <p:spPr>
          <a:xfrm>
            <a:off x="578734" y="18369913"/>
            <a:ext cx="10938076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Figure S2: (a)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Original Western Blot images without cropping for three different repeats showing the downregulatory effect on MOAP1 protein by hcmv-miR-UL70-3p. The image(s) contain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sym typeface="Symbol" panose="05050102010706020507" pitchFamily="18" charset="2"/>
              </a:rPr>
              <a:t>-actin as a loading control (45kDa) and targeted gene MOAP1 (39.5kDa). The images were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taken from the Chemiscope (Make: Clinx, China). 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(b)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Triplicates of the original Western Blots images without cropping showing the downregulatory effect on MOAP1 protein by siRNA of MOAP1 and hcmv-miR-UL70-3p. The image(s) contain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sym typeface="Symbol" panose="05050102010706020507" pitchFamily="18" charset="2"/>
              </a:rPr>
              <a:t>-actin as a loading control (45kDa) and targeted gene MOAP1(39.5kDa). The images were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taken from the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</a:rPr>
              <a:t>Chemiscope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 (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Make: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</a:rPr>
              <a:t>Clinx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, China).  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D82B85AB-514C-4138-BCA8-3272542E988A}"/>
              </a:ext>
            </a:extLst>
          </p:cNvPr>
          <p:cNvSpPr txBox="1"/>
          <p:nvPr/>
        </p:nvSpPr>
        <p:spPr>
          <a:xfrm>
            <a:off x="1312860" y="11783770"/>
            <a:ext cx="1678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I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tin </a:t>
            </a:r>
            <a:r>
              <a:rPr lang="en-IN" dirty="0">
                <a:latin typeface="Times New Roman" panose="02020603050405020304" pitchFamily="18" charset="0"/>
                <a:cs typeface="Times New Roman" panose="02020603050405020304" pitchFamily="18" charset="0"/>
              </a:rPr>
              <a:t>(45kDa)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E0FCA36B-D3A7-414F-886D-9BBDA1711B4D}"/>
              </a:ext>
            </a:extLst>
          </p:cNvPr>
          <p:cNvSpPr txBox="1"/>
          <p:nvPr/>
        </p:nvSpPr>
        <p:spPr>
          <a:xfrm>
            <a:off x="975366" y="14729887"/>
            <a:ext cx="2005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AP1</a:t>
            </a:r>
            <a:r>
              <a:rPr lang="en-I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39.5kDa)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26AED8E0-0DC3-41F8-9881-00E3FA347BB1}"/>
              </a:ext>
            </a:extLst>
          </p:cNvPr>
          <p:cNvSpPr txBox="1"/>
          <p:nvPr/>
        </p:nvSpPr>
        <p:spPr>
          <a:xfrm>
            <a:off x="3790191" y="10260045"/>
            <a:ext cx="9989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eat 1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6A922282-E9C7-4D45-8355-9E9C69383B90}"/>
              </a:ext>
            </a:extLst>
          </p:cNvPr>
          <p:cNvSpPr txBox="1"/>
          <p:nvPr/>
        </p:nvSpPr>
        <p:spPr>
          <a:xfrm>
            <a:off x="6481393" y="10334288"/>
            <a:ext cx="9989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eat 2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611EF9C7-5B64-43F4-B3CF-2812ECE316DC}"/>
              </a:ext>
            </a:extLst>
          </p:cNvPr>
          <p:cNvSpPr txBox="1"/>
          <p:nvPr/>
        </p:nvSpPr>
        <p:spPr>
          <a:xfrm>
            <a:off x="9485646" y="10298037"/>
            <a:ext cx="9989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eat 3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4A51A67D-E467-42D7-B2A9-11FFEBD043AA}"/>
              </a:ext>
            </a:extLst>
          </p:cNvPr>
          <p:cNvSpPr txBox="1"/>
          <p:nvPr/>
        </p:nvSpPr>
        <p:spPr>
          <a:xfrm rot="16200000">
            <a:off x="2809795" y="16041212"/>
            <a:ext cx="1960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(untreated)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9EE92B63-4B0C-4C4D-B14B-B86955B0BF40}"/>
              </a:ext>
            </a:extLst>
          </p:cNvPr>
          <p:cNvSpPr txBox="1"/>
          <p:nvPr/>
        </p:nvSpPr>
        <p:spPr>
          <a:xfrm rot="16200000">
            <a:off x="3940852" y="15411662"/>
            <a:ext cx="671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IN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IN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IN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A47866D8-B3CA-4021-BA1B-E8454E044E75}"/>
              </a:ext>
            </a:extLst>
          </p:cNvPr>
          <p:cNvSpPr txBox="1"/>
          <p:nvPr/>
        </p:nvSpPr>
        <p:spPr>
          <a:xfrm rot="16200000">
            <a:off x="3515167" y="16300929"/>
            <a:ext cx="25780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IN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IN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IN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IN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siRNA of MOAP1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992B1493-E459-487C-927F-CB439236686E}"/>
              </a:ext>
            </a:extLst>
          </p:cNvPr>
          <p:cNvSpPr txBox="1"/>
          <p:nvPr/>
        </p:nvSpPr>
        <p:spPr>
          <a:xfrm rot="16200000">
            <a:off x="3923726" y="16425932"/>
            <a:ext cx="28280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IN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IN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IN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IN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miR-UL70-3p mimic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052B5CF8-13CD-42B0-8BCD-F0F884F5EB72}"/>
              </a:ext>
            </a:extLst>
          </p:cNvPr>
          <p:cNvSpPr txBox="1"/>
          <p:nvPr/>
        </p:nvSpPr>
        <p:spPr>
          <a:xfrm rot="16200000">
            <a:off x="8241447" y="16169398"/>
            <a:ext cx="1960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(untreated)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B44FEDF3-B678-4E4D-B26B-0C862000FF92}"/>
              </a:ext>
            </a:extLst>
          </p:cNvPr>
          <p:cNvSpPr txBox="1"/>
          <p:nvPr/>
        </p:nvSpPr>
        <p:spPr>
          <a:xfrm rot="16200000">
            <a:off x="9370532" y="15543919"/>
            <a:ext cx="671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IN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IN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IN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B5C45334-F7A8-452C-84B5-E384A56FF409}"/>
              </a:ext>
            </a:extLst>
          </p:cNvPr>
          <p:cNvSpPr txBox="1"/>
          <p:nvPr/>
        </p:nvSpPr>
        <p:spPr>
          <a:xfrm rot="16200000">
            <a:off x="9085650" y="16415227"/>
            <a:ext cx="25780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IN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IN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IN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IN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siRNA of MOAP1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3185CCF7-5FD4-44E2-AF5D-DC2CC2DF25D6}"/>
              </a:ext>
            </a:extLst>
          </p:cNvPr>
          <p:cNvSpPr txBox="1"/>
          <p:nvPr/>
        </p:nvSpPr>
        <p:spPr>
          <a:xfrm rot="16200000">
            <a:off x="9556818" y="16541378"/>
            <a:ext cx="28280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IN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IN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IN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IN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miR-UL70-3p mimic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13D3916C-8E35-4183-A303-3F0001A70ADD}"/>
              </a:ext>
            </a:extLst>
          </p:cNvPr>
          <p:cNvSpPr txBox="1"/>
          <p:nvPr/>
        </p:nvSpPr>
        <p:spPr>
          <a:xfrm rot="16200000">
            <a:off x="5349719" y="16266257"/>
            <a:ext cx="1960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(untreated)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9AE226F6-CFB4-41B9-84E5-2701061D3B1D}"/>
              </a:ext>
            </a:extLst>
          </p:cNvPr>
          <p:cNvSpPr txBox="1"/>
          <p:nvPr/>
        </p:nvSpPr>
        <p:spPr>
          <a:xfrm rot="16200000">
            <a:off x="6587445" y="15659558"/>
            <a:ext cx="671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IN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IN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IN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16C14447-1C54-4396-91ED-50B6A3D4EE20}"/>
              </a:ext>
            </a:extLst>
          </p:cNvPr>
          <p:cNvSpPr txBox="1"/>
          <p:nvPr/>
        </p:nvSpPr>
        <p:spPr>
          <a:xfrm rot="16200000">
            <a:off x="6344327" y="16541376"/>
            <a:ext cx="25780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IN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IN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IN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IN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siRNA of MOAP1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6D94ED26-05DF-4383-ABF8-D6CC5911EF3E}"/>
              </a:ext>
            </a:extLst>
          </p:cNvPr>
          <p:cNvSpPr txBox="1"/>
          <p:nvPr/>
        </p:nvSpPr>
        <p:spPr>
          <a:xfrm rot="16200000">
            <a:off x="7048440" y="16556767"/>
            <a:ext cx="25378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IN" sz="16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I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IN" sz="16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I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miR-UL70-3p mimic</a:t>
            </a:r>
          </a:p>
        </p:txBody>
      </p:sp>
      <p:pic>
        <p:nvPicPr>
          <p:cNvPr id="54" name="Picture 53">
            <a:extLst>
              <a:ext uri="{FF2B5EF4-FFF2-40B4-BE49-F238E27FC236}">
                <a16:creationId xmlns:a16="http://schemas.microsoft.com/office/drawing/2014/main" id="{BD5C1FD0-6757-462E-B2E3-943B85A5FE1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967301" y="10695198"/>
            <a:ext cx="2688569" cy="2706859"/>
          </a:xfrm>
          <a:prstGeom prst="rect">
            <a:avLst/>
          </a:prstGeom>
        </p:spPr>
      </p:pic>
      <p:pic>
        <p:nvPicPr>
          <p:cNvPr id="55" name="Picture 54">
            <a:extLst>
              <a:ext uri="{FF2B5EF4-FFF2-40B4-BE49-F238E27FC236}">
                <a16:creationId xmlns:a16="http://schemas.microsoft.com/office/drawing/2014/main" id="{0919318F-D070-462C-9DE6-EDF7EC31604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845306" y="10787625"/>
            <a:ext cx="2469094" cy="2584928"/>
          </a:xfrm>
          <a:prstGeom prst="rect">
            <a:avLst/>
          </a:prstGeom>
        </p:spPr>
      </p:pic>
      <p:pic>
        <p:nvPicPr>
          <p:cNvPr id="56" name="Picture 55">
            <a:extLst>
              <a:ext uri="{FF2B5EF4-FFF2-40B4-BE49-F238E27FC236}">
                <a16:creationId xmlns:a16="http://schemas.microsoft.com/office/drawing/2014/main" id="{483CE114-DB6D-4DE7-8F34-3707A5910DAC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b="18673"/>
          <a:stretch/>
        </p:blipFill>
        <p:spPr>
          <a:xfrm>
            <a:off x="8653452" y="10847017"/>
            <a:ext cx="2365453" cy="2300585"/>
          </a:xfrm>
          <a:prstGeom prst="rect">
            <a:avLst/>
          </a:prstGeom>
        </p:spPr>
      </p:pic>
      <p:sp>
        <p:nvSpPr>
          <p:cNvPr id="57" name="TextBox 56">
            <a:extLst>
              <a:ext uri="{FF2B5EF4-FFF2-40B4-BE49-F238E27FC236}">
                <a16:creationId xmlns:a16="http://schemas.microsoft.com/office/drawing/2014/main" id="{DC24E80F-A5C7-497D-8A8E-490AAD1A7868}"/>
              </a:ext>
            </a:extLst>
          </p:cNvPr>
          <p:cNvSpPr txBox="1"/>
          <p:nvPr/>
        </p:nvSpPr>
        <p:spPr>
          <a:xfrm>
            <a:off x="72147" y="47832"/>
            <a:ext cx="609407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26981235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</TotalTime>
  <Words>218</Words>
  <Application>Microsoft Office PowerPoint</Application>
  <PresentationFormat>Custom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hishek Pandeya</dc:creator>
  <cp:lastModifiedBy>Abhishek Pandeya</cp:lastModifiedBy>
  <cp:revision>4</cp:revision>
  <cp:lastPrinted>2021-12-06T21:32:25Z</cp:lastPrinted>
  <dcterms:created xsi:type="dcterms:W3CDTF">2021-12-05T20:20:09Z</dcterms:created>
  <dcterms:modified xsi:type="dcterms:W3CDTF">2021-12-06T21:32:25Z</dcterms:modified>
</cp:coreProperties>
</file>